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obj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E76A70-CCF5-476E-A99D-CA6F27505E07}" type="datetimeFigureOut">
              <a:rPr lang="zh-CN" altLang="en-US" smtClean="0"/>
              <a:pPr/>
              <a:t>2019/4/4 Thurs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8055ED-99A2-4D00-AC0E-740EDA70D70F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5552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2" Type="http://schemas.openxmlformats.org/officeDocument/2006/relationships/theme" Target="../theme/theme1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E76A70-CCF5-476E-A99D-CA6F27505E07}" type="datetimeFigureOut">
              <a:rPr lang="zh-CN" altLang="en-US" smtClean="0"/>
              <a:pPr/>
              <a:t>2019/4/4 Thurs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8055ED-99A2-4D00-AC0E-740EDA70D70F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918051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表格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61733209"/>
              </p:ext>
            </p:extLst>
          </p:nvPr>
        </p:nvGraphicFramePr>
        <p:xfrm>
          <a:off x="1872000" y="1673351"/>
          <a:ext cx="8055864" cy="4436801"/>
        </p:xfrm>
        <a:graphic>
          <a:graphicData uri="http://schemas.openxmlformats.org/drawingml/2006/table">
            <a:tbl>
              <a:tblPr firstRow="1" firstCol="1" bandRow="1"/>
              <a:tblGrid>
                <a:gridCol w="2102782"/>
                <a:gridCol w="2611675"/>
                <a:gridCol w="3341407"/>
              </a:tblGrid>
              <a:tr h="351733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500" b="1" kern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Gene </a:t>
                      </a:r>
                      <a:r>
                        <a:rPr lang="en-US" sz="1500" b="1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ID</a:t>
                      </a:r>
                      <a:endParaRPr lang="zh-CN" sz="1500" b="1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1500" b="1" kern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Annotation</a:t>
                      </a:r>
                      <a:endParaRPr lang="zh-CN" sz="1500" b="1" kern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500" b="1" kern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Primer (5</a:t>
                      </a:r>
                      <a:r>
                        <a:rPr lang="en-US" sz="1500" b="1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’ to 3</a:t>
                      </a:r>
                      <a:r>
                        <a:rPr lang="en-US" sz="1500" b="1" kern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’)</a:t>
                      </a:r>
                      <a:endParaRPr lang="zh-CN" sz="1500" b="1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51733"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HORVU7Hr1G047210</a:t>
                      </a:r>
                      <a:endParaRPr lang="zh-CN" sz="14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Phosphate transporter PHO1-3</a:t>
                      </a:r>
                      <a:endParaRPr lang="zh-CN" sz="14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4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F</a:t>
                      </a:r>
                      <a:r>
                        <a:rPr lang="en-US" sz="1400" kern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: CTTCCTTTGAGACACCCACCG</a:t>
                      </a:r>
                      <a:endParaRPr lang="zh-CN" sz="14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327472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4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R</a:t>
                      </a:r>
                      <a:r>
                        <a:rPr lang="en-US" sz="1400" kern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: GCTTGGAGAACTTTACCATTGGC</a:t>
                      </a:r>
                      <a:endParaRPr lang="zh-CN" sz="14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21012"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HORVU2Hr1G094690</a:t>
                      </a:r>
                      <a:endParaRPr lang="zh-CN" sz="14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kern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SPX-MFS1</a:t>
                      </a:r>
                      <a:endParaRPr lang="zh-CN" sz="14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4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F</a:t>
                      </a:r>
                      <a:r>
                        <a:rPr lang="en-US" sz="1400" kern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: TGTGGTTGCTGATGCGACG</a:t>
                      </a:r>
                      <a:endParaRPr lang="zh-CN" sz="14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11286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4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R</a:t>
                      </a:r>
                      <a:r>
                        <a:rPr lang="en-US" sz="1400" kern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: GGGTGATGTTGAGGAGCATGT</a:t>
                      </a:r>
                      <a:endParaRPr lang="zh-CN" sz="14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51733"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HORVU6Hr1G065710</a:t>
                      </a:r>
                      <a:endParaRPr lang="zh-CN" sz="14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kern="1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SPX-MFS2</a:t>
                      </a:r>
                      <a:endParaRPr lang="zh-CN" sz="14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4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F</a:t>
                      </a:r>
                      <a:r>
                        <a:rPr lang="en-US" sz="1400" kern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: GCTCTCAGCACACAGTCATC</a:t>
                      </a:r>
                      <a:endParaRPr lang="zh-CN" sz="14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11434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4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R</a:t>
                      </a:r>
                      <a:r>
                        <a:rPr lang="en-US" sz="1400" kern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: CTCTGCGTTTTCATTCCGCC</a:t>
                      </a:r>
                      <a:endParaRPr lang="zh-CN" sz="14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51733"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HORVU2Hr1G079720</a:t>
                      </a:r>
                      <a:endParaRPr lang="zh-CN" sz="14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Sugar transporter protein 7</a:t>
                      </a:r>
                      <a:endParaRPr lang="zh-CN" sz="14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4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F</a:t>
                      </a:r>
                      <a:r>
                        <a:rPr lang="en-US" sz="1400" kern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: CTGGTGCTGATGTGCCTGTA</a:t>
                      </a:r>
                      <a:endParaRPr lang="zh-CN" sz="14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51733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4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R</a:t>
                      </a:r>
                      <a:r>
                        <a:rPr lang="en-US" sz="1400" kern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: CCGCCATGAAAACCGTCATC</a:t>
                      </a:r>
                      <a:endParaRPr lang="zh-CN" sz="14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51733"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HORVU3Hr1G096510</a:t>
                      </a:r>
                      <a:endParaRPr lang="zh-CN" sz="14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kern="1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Auxin</a:t>
                      </a:r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 response factor 2</a:t>
                      </a:r>
                      <a:endParaRPr lang="zh-CN" sz="14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4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F</a:t>
                      </a:r>
                      <a:r>
                        <a:rPr lang="en-US" sz="1400" kern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: CATTCAGCAAGCTCCCAACA</a:t>
                      </a:r>
                      <a:endParaRPr lang="zh-CN" sz="14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51733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4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R</a:t>
                      </a:r>
                      <a:r>
                        <a:rPr lang="en-US" sz="1400" kern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: GCAACTCCTTGTGGAAGCAC </a:t>
                      </a:r>
                      <a:endParaRPr lang="zh-CN" sz="14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51733">
                <a:tc rowSpan="2">
                  <a:txBody>
                    <a:bodyPr/>
                    <a:lstStyle/>
                    <a:p>
                      <a:pPr indent="133350" algn="ctr">
                        <a:spcAft>
                          <a:spcPts val="0"/>
                        </a:spcAft>
                      </a:pPr>
                      <a:r>
                        <a:rPr lang="en-US" sz="1400" kern="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HvACTIN</a:t>
                      </a:r>
                      <a:endParaRPr lang="zh-CN" sz="14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Reference gene</a:t>
                      </a:r>
                      <a:endParaRPr lang="zh-CN" sz="14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4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F</a:t>
                      </a:r>
                      <a:r>
                        <a:rPr lang="en-US" sz="1400" kern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: TCGCTCCACCTGAGAGGAAG</a:t>
                      </a:r>
                      <a:endParaRPr lang="zh-CN" sz="14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51733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4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R</a:t>
                      </a:r>
                      <a:r>
                        <a:rPr lang="en-US" sz="1400" kern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: GCTAGGATGGACCCTCCGAT</a:t>
                      </a:r>
                      <a:endParaRPr lang="zh-CN" sz="14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7" name="矩形 6"/>
          <p:cNvSpPr/>
          <p:nvPr/>
        </p:nvSpPr>
        <p:spPr>
          <a:xfrm>
            <a:off x="1746069" y="1104250"/>
            <a:ext cx="4867166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indent="266700" algn="just">
              <a:spcAft>
                <a:spcPts val="0"/>
              </a:spcAft>
            </a:pPr>
            <a:r>
              <a:rPr lang="en-US" altLang="zh-CN" sz="1600" kern="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able </a:t>
            </a:r>
            <a:r>
              <a:rPr lang="en-US" altLang="zh-CN" sz="1600" kern="1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1. </a:t>
            </a:r>
            <a:r>
              <a:rPr lang="en-US" altLang="zh-CN" sz="1600" kern="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rimes </a:t>
            </a:r>
            <a:r>
              <a:rPr lang="en-US" altLang="zh-CN" sz="1600" kern="1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used in </a:t>
            </a:r>
            <a:r>
              <a:rPr lang="en-US" altLang="zh-CN" sz="1600" kern="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q</a:t>
            </a:r>
            <a:r>
              <a:rPr lang="en-US" altLang="zh-CN" sz="1600" kern="1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uantitative </a:t>
            </a:r>
            <a:r>
              <a:rPr lang="en-US" altLang="zh-CN" sz="1600" kern="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eal-time </a:t>
            </a:r>
            <a:r>
              <a:rPr lang="en-US" altLang="zh-CN" sz="1600" kern="1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CR.</a:t>
            </a:r>
            <a:endParaRPr lang="zh-CN" altLang="zh-CN" sz="1600" kern="100" dirty="0">
              <a:latin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5001859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357</TotalTime>
  <Words>77</Words>
  <Application>Microsoft Office PowerPoint</Application>
  <PresentationFormat>宽屏</PresentationFormat>
  <Paragraphs>28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宋体</vt:lpstr>
      <vt:lpstr>Arial</vt:lpstr>
      <vt:lpstr>Calibri</vt:lpstr>
      <vt:lpstr>Calibri Light</vt:lpstr>
      <vt:lpstr>Times New Roman</vt:lpstr>
      <vt:lpstr>Office 主题</vt:lpstr>
      <vt:lpstr>PowerPoint 演示文稿</vt:lpstr>
    </vt:vector>
  </TitlesOfParts>
  <Company>MS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 in barley_Figures and tables BMC</dc:title>
  <dc:creator>USER-</dc:creator>
  <dc:description/>
  <cp:lastModifiedBy>USER-</cp:lastModifiedBy>
  <cp:revision>61</cp:revision>
  <dcterms:created xsi:type="dcterms:W3CDTF">2018-12-09T11:22:19Z</dcterms:created>
  <dcterms:modified xsi:type="dcterms:W3CDTF">2019-04-04T03:30:3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Presentation">
    <vt:lpwstr>P in barley_Figures and tables BMC</vt:lpwstr>
  </property>
  <property fmtid="{D5CDD505-2E9C-101B-9397-08002B2CF9AE}" pid="3" name="SlideDescription">
    <vt:lpwstr/>
  </property>
</Properties>
</file>